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5029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312840" y="685440"/>
            <a:ext cx="623232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1742B7-EF0F-43AF-B0FE-503B0FFC0AF5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37BD5D-4AB9-469A-A72A-610C356D64A5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1"/>
          <p:cNvSpPr>
            <a:spLocks noGrp="1"/>
          </p:cNvSpPr>
          <p:nvPr>
            <p:ph type="sldImg"/>
          </p:nvPr>
        </p:nvSpPr>
        <p:spPr>
          <a:xfrm>
            <a:off x="312840" y="685800"/>
            <a:ext cx="6232320" cy="3429000"/>
          </a:xfrm>
          <a:prstGeom prst="rect">
            <a:avLst/>
          </a:prstGeom>
          <a:ln w="0">
            <a:noFill/>
          </a:ln>
        </p:spPr>
      </p:sp>
      <p:sp>
        <p:nvSpPr>
          <p:cNvPr id="14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1CDDB-FF54-47D9-87FA-7EAF763AF9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172880"/>
            <a:ext cx="82296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2907000"/>
            <a:ext cx="82296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4A935-7576-4DF9-A55D-BC30DCDBE7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17288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17288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290700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290700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CDB09-CB27-49B3-9707-A2C7311948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172880"/>
            <a:ext cx="26496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172880"/>
            <a:ext cx="26496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172880"/>
            <a:ext cx="26496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2907000"/>
            <a:ext cx="26496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2907000"/>
            <a:ext cx="26496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2907000"/>
            <a:ext cx="26496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518A38-BC67-456B-9752-83FBCBC9D2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172880"/>
            <a:ext cx="8229600" cy="331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C8BB7-D2CF-40A6-8ABD-7E962443F9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172880"/>
            <a:ext cx="8229600" cy="331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80E12-F2AC-409E-A803-65DC69B40B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172880"/>
            <a:ext cx="4015800" cy="331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172880"/>
            <a:ext cx="4015800" cy="331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4490F-7910-4261-91F8-1A6B57D5EB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98F70-2AEB-46A8-8DD1-4BEC7CC366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01600"/>
            <a:ext cx="8229600" cy="388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B50EB9-C6EB-438C-85DB-20AD6C9B0E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17288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172880"/>
            <a:ext cx="4015800" cy="331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290700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6208F-93B7-4533-8EF3-DEED217BB8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172880"/>
            <a:ext cx="4015800" cy="331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17288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290700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C1DC81-D149-48E9-8471-DDD4952968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17288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172880"/>
            <a:ext cx="40158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2907000"/>
            <a:ext cx="8229600" cy="158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21232-8AF1-4127-BE0B-EC627B20DA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016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172880"/>
            <a:ext cx="8229600" cy="331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0000"/>
          </a:bodyPr>
          <a:p>
            <a:pPr marL="274320" indent="-2743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59436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 indent="-1828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280160" indent="-1828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645920" indent="-1828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645920" indent="-1828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645920" indent="-1828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4579920"/>
            <a:ext cx="2133720" cy="34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4579920"/>
            <a:ext cx="2895840" cy="34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4579920"/>
            <a:ext cx="2133720" cy="34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690D15-6B65-46D5-A941-4C210FF31E3C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295200" y="79200"/>
            <a:ext cx="8553600" cy="4876560"/>
            <a:chOff x="295200" y="79200"/>
            <a:chExt cx="8553600" cy="4876560"/>
          </a:xfrm>
        </p:grpSpPr>
        <p:grpSp>
          <p:nvGrpSpPr>
            <p:cNvPr id="49" name="Gruppo 95"/>
            <p:cNvGrpSpPr/>
            <p:nvPr/>
          </p:nvGrpSpPr>
          <p:grpSpPr>
            <a:xfrm>
              <a:off x="1022040" y="2904840"/>
              <a:ext cx="1676880" cy="374760"/>
              <a:chOff x="1022040" y="2904840"/>
              <a:chExt cx="1676880" cy="374760"/>
            </a:xfrm>
          </p:grpSpPr>
          <p:sp>
            <p:nvSpPr>
              <p:cNvPr id="50" name="AutoShape 24"/>
              <p:cNvSpPr/>
              <p:nvPr/>
            </p:nvSpPr>
            <p:spPr>
              <a:xfrm rot="5400000">
                <a:off x="945720" y="3016080"/>
                <a:ext cx="304920" cy="152280"/>
              </a:xfrm>
              <a:custGeom>
                <a:avLst/>
                <a:gdLst>
                  <a:gd name="textAreaLeft" fmla="*/ 0 w 304920"/>
                  <a:gd name="textAreaRight" fmla="*/ 305280 w 304920"/>
                  <a:gd name="textAreaTop" fmla="*/ 0 h 152280"/>
                  <a:gd name="textAreaBottom" fmla="*/ 152640 h 152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 Box 25"/>
              <p:cNvSpPr/>
              <p:nvPr/>
            </p:nvSpPr>
            <p:spPr>
              <a:xfrm>
                <a:off x="1251000" y="2904840"/>
                <a:ext cx="1447920" cy="374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BV Vaccine: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2" name="Group 98"/>
            <p:cNvGrpSpPr/>
            <p:nvPr/>
          </p:nvGrpSpPr>
          <p:grpSpPr>
            <a:xfrm>
              <a:off x="4273200" y="2626920"/>
              <a:ext cx="3413520" cy="798120"/>
              <a:chOff x="4273200" y="2626920"/>
              <a:chExt cx="3413520" cy="798120"/>
            </a:xfrm>
          </p:grpSpPr>
          <p:sp>
            <p:nvSpPr>
              <p:cNvPr id="53" name="AutoShape 33"/>
              <p:cNvSpPr/>
              <p:nvPr/>
            </p:nvSpPr>
            <p:spPr>
              <a:xfrm rot="5400000">
                <a:off x="4196880" y="2936520"/>
                <a:ext cx="304560" cy="152280"/>
              </a:xfrm>
              <a:custGeom>
                <a:avLst/>
                <a:gdLst>
                  <a:gd name="textAreaLeft" fmla="*/ 0 w 304560"/>
                  <a:gd name="textAreaRight" fmla="*/ 304920 w 304560"/>
                  <a:gd name="textAreaTop" fmla="*/ 0 h 152280"/>
                  <a:gd name="textAreaBottom" fmla="*/ 152640 h 152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b3b3b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4" name="Gruppo 99"/>
              <p:cNvGrpSpPr/>
              <p:nvPr/>
            </p:nvGrpSpPr>
            <p:grpSpPr>
              <a:xfrm>
                <a:off x="4492800" y="2626920"/>
                <a:ext cx="3193920" cy="798120"/>
                <a:chOff x="4492800" y="2626920"/>
                <a:chExt cx="3193920" cy="798120"/>
              </a:xfrm>
            </p:grpSpPr>
            <p:sp>
              <p:nvSpPr>
                <p:cNvPr id="55" name="Text Box 28"/>
                <p:cNvSpPr/>
                <p:nvPr/>
              </p:nvSpPr>
              <p:spPr>
                <a:xfrm>
                  <a:off x="4653000" y="2626920"/>
                  <a:ext cx="30337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Group A= placebo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Text Box 31"/>
                <p:cNvSpPr/>
                <p:nvPr/>
              </p:nvSpPr>
              <p:spPr>
                <a:xfrm>
                  <a:off x="4653000" y="2881440"/>
                  <a:ext cx="30337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Group B= LE-IFN</a:t>
                  </a:r>
                  <a:r>
                    <a:rPr b="0" lang="it-IT" sz="12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</a:t>
                  </a: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 1MU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Text Box 32"/>
                <p:cNvSpPr/>
                <p:nvPr/>
              </p:nvSpPr>
              <p:spPr>
                <a:xfrm>
                  <a:off x="4653000" y="3148560"/>
                  <a:ext cx="30337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Group C= LE-IFN</a:t>
                  </a:r>
                  <a:r>
                    <a:rPr b="0" lang="it-IT" sz="12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</a:t>
                  </a: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 3MU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Line 34"/>
                <p:cNvSpPr/>
                <p:nvPr/>
              </p:nvSpPr>
              <p:spPr>
                <a:xfrm flipV="1">
                  <a:off x="4502160" y="2735280"/>
                  <a:ext cx="152280" cy="163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Line 35"/>
                <p:cNvSpPr/>
                <p:nvPr/>
              </p:nvSpPr>
              <p:spPr>
                <a:xfrm>
                  <a:off x="4492800" y="2965680"/>
                  <a:ext cx="133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Line 36"/>
                <p:cNvSpPr/>
                <p:nvPr/>
              </p:nvSpPr>
              <p:spPr>
                <a:xfrm>
                  <a:off x="4492800" y="3017520"/>
                  <a:ext cx="133200" cy="200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61" name="Line 40"/>
            <p:cNvSpPr/>
            <p:nvPr/>
          </p:nvSpPr>
          <p:spPr>
            <a:xfrm>
              <a:off x="3541680" y="637920"/>
              <a:ext cx="0" cy="8568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41"/>
            <p:cNvSpPr/>
            <p:nvPr/>
          </p:nvSpPr>
          <p:spPr>
            <a:xfrm>
              <a:off x="3765600" y="637920"/>
              <a:ext cx="0" cy="8568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42"/>
            <p:cNvSpPr/>
            <p:nvPr/>
          </p:nvSpPr>
          <p:spPr>
            <a:xfrm>
              <a:off x="1416240" y="637920"/>
              <a:ext cx="463320" cy="2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43"/>
            <p:cNvSpPr/>
            <p:nvPr/>
          </p:nvSpPr>
          <p:spPr>
            <a:xfrm>
              <a:off x="314280" y="1296720"/>
              <a:ext cx="8447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45"/>
            <p:cNvSpPr/>
            <p:nvPr/>
          </p:nvSpPr>
          <p:spPr>
            <a:xfrm>
              <a:off x="895320" y="637920"/>
              <a:ext cx="461880" cy="2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AutoShape 46"/>
            <p:cNvSpPr/>
            <p:nvPr/>
          </p:nvSpPr>
          <p:spPr>
            <a:xfrm rot="5400000">
              <a:off x="946080" y="1055160"/>
              <a:ext cx="330120" cy="15264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640"/>
                <a:gd name="textAreaBottom" fmla="*/ 153000 h 152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AutoShape 47"/>
            <p:cNvSpPr/>
            <p:nvPr/>
          </p:nvSpPr>
          <p:spPr>
            <a:xfrm rot="5400000">
              <a:off x="1469880" y="1055160"/>
              <a:ext cx="330120" cy="15264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640"/>
                <a:gd name="textAreaBottom" fmla="*/ 153000 h 152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49"/>
            <p:cNvSpPr/>
            <p:nvPr/>
          </p:nvSpPr>
          <p:spPr>
            <a:xfrm>
              <a:off x="1152360" y="637920"/>
              <a:ext cx="412920" cy="2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AutoShape 50"/>
            <p:cNvSpPr/>
            <p:nvPr/>
          </p:nvSpPr>
          <p:spPr>
            <a:xfrm rot="5400000">
              <a:off x="1250640" y="1055520"/>
              <a:ext cx="330120" cy="15228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AutoShape 51"/>
            <p:cNvSpPr/>
            <p:nvPr/>
          </p:nvSpPr>
          <p:spPr>
            <a:xfrm rot="5400000">
              <a:off x="1164960" y="1055520"/>
              <a:ext cx="330120" cy="15228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53"/>
            <p:cNvSpPr/>
            <p:nvPr/>
          </p:nvSpPr>
          <p:spPr>
            <a:xfrm>
              <a:off x="6505560" y="637920"/>
              <a:ext cx="485640" cy="239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55"/>
            <p:cNvSpPr/>
            <p:nvPr/>
          </p:nvSpPr>
          <p:spPr>
            <a:xfrm>
              <a:off x="5616720" y="637920"/>
              <a:ext cx="412560" cy="2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7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AutoShape 56"/>
            <p:cNvSpPr/>
            <p:nvPr/>
          </p:nvSpPr>
          <p:spPr>
            <a:xfrm rot="5400000">
              <a:off x="5708520" y="1055160"/>
              <a:ext cx="330120" cy="15264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640"/>
                <a:gd name="textAreaBottom" fmla="*/ 153000 h 152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AutoShape 57"/>
            <p:cNvSpPr/>
            <p:nvPr/>
          </p:nvSpPr>
          <p:spPr>
            <a:xfrm rot="5400000">
              <a:off x="5622840" y="1055160"/>
              <a:ext cx="330120" cy="15264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640"/>
                <a:gd name="textAreaBottom" fmla="*/ 153000 h 152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AutoShape 59"/>
            <p:cNvSpPr/>
            <p:nvPr/>
          </p:nvSpPr>
          <p:spPr>
            <a:xfrm rot="5400000">
              <a:off x="6622920" y="1055160"/>
              <a:ext cx="330120" cy="15264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640"/>
                <a:gd name="textAreaBottom" fmla="*/ 153000 h 152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AutoShape 60"/>
            <p:cNvSpPr/>
            <p:nvPr/>
          </p:nvSpPr>
          <p:spPr>
            <a:xfrm rot="5400000">
              <a:off x="6537240" y="1055160"/>
              <a:ext cx="330120" cy="15264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640"/>
                <a:gd name="textAreaBottom" fmla="*/ 153000 h 152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62"/>
            <p:cNvSpPr/>
            <p:nvPr/>
          </p:nvSpPr>
          <p:spPr>
            <a:xfrm>
              <a:off x="7473960" y="637920"/>
              <a:ext cx="460440" cy="239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AutoShape 63"/>
            <p:cNvSpPr/>
            <p:nvPr/>
          </p:nvSpPr>
          <p:spPr>
            <a:xfrm rot="5400000">
              <a:off x="7613280" y="1055520"/>
              <a:ext cx="330120" cy="15228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AutoShape 64"/>
            <p:cNvSpPr/>
            <p:nvPr/>
          </p:nvSpPr>
          <p:spPr>
            <a:xfrm rot="5400000">
              <a:off x="7527600" y="1055520"/>
              <a:ext cx="330120" cy="15228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AutoShape 66"/>
            <p:cNvSpPr/>
            <p:nvPr/>
          </p:nvSpPr>
          <p:spPr>
            <a:xfrm rot="5400000">
              <a:off x="8527680" y="1055520"/>
              <a:ext cx="330120" cy="15228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AutoShape 67"/>
            <p:cNvSpPr/>
            <p:nvPr/>
          </p:nvSpPr>
          <p:spPr>
            <a:xfrm rot="5400000">
              <a:off x="8442000" y="1055520"/>
              <a:ext cx="330120" cy="15228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68"/>
            <p:cNvSpPr/>
            <p:nvPr/>
          </p:nvSpPr>
          <p:spPr>
            <a:xfrm>
              <a:off x="8388360" y="637920"/>
              <a:ext cx="460440" cy="239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AutoShape 69"/>
            <p:cNvSpPr/>
            <p:nvPr/>
          </p:nvSpPr>
          <p:spPr>
            <a:xfrm flipV="1" rot="16200000">
              <a:off x="933120" y="1373760"/>
              <a:ext cx="304920" cy="152280"/>
            </a:xfrm>
            <a:custGeom>
              <a:avLst/>
              <a:gdLst>
                <a:gd name="textAreaLeft" fmla="*/ 0 w 304920"/>
                <a:gd name="textAreaRight" fmla="*/ 305280 w 304920"/>
                <a:gd name="textAreaTop" fmla="*/ -360 h 152280"/>
                <a:gd name="textAreaBottom" fmla="*/ 15228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AutoShape 70"/>
            <p:cNvSpPr/>
            <p:nvPr/>
          </p:nvSpPr>
          <p:spPr>
            <a:xfrm flipV="1" rot="16200000">
              <a:off x="1441080" y="1373760"/>
              <a:ext cx="304920" cy="152280"/>
            </a:xfrm>
            <a:custGeom>
              <a:avLst/>
              <a:gdLst>
                <a:gd name="textAreaLeft" fmla="*/ 0 w 304920"/>
                <a:gd name="textAreaRight" fmla="*/ 305280 w 304920"/>
                <a:gd name="textAreaTop" fmla="*/ -360 h 152280"/>
                <a:gd name="textAreaBottom" fmla="*/ 15228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AutoShape 71"/>
            <p:cNvSpPr/>
            <p:nvPr/>
          </p:nvSpPr>
          <p:spPr>
            <a:xfrm flipV="1" rot="16200000">
              <a:off x="4323960" y="1373760"/>
              <a:ext cx="304920" cy="152280"/>
            </a:xfrm>
            <a:custGeom>
              <a:avLst/>
              <a:gdLst>
                <a:gd name="textAreaLeft" fmla="*/ 0 w 304920"/>
                <a:gd name="textAreaRight" fmla="*/ 305280 w 304920"/>
                <a:gd name="textAreaTop" fmla="*/ -360 h 152280"/>
                <a:gd name="textAreaBottom" fmla="*/ 15228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AutoShape 72"/>
            <p:cNvSpPr/>
            <p:nvPr/>
          </p:nvSpPr>
          <p:spPr>
            <a:xfrm flipV="1" rot="16200000">
              <a:off x="4831920" y="1373760"/>
              <a:ext cx="304920" cy="152280"/>
            </a:xfrm>
            <a:custGeom>
              <a:avLst/>
              <a:gdLst>
                <a:gd name="textAreaLeft" fmla="*/ 0 w 304920"/>
                <a:gd name="textAreaRight" fmla="*/ 305280 w 304920"/>
                <a:gd name="textAreaTop" fmla="*/ -360 h 152280"/>
                <a:gd name="textAreaBottom" fmla="*/ 15228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75"/>
            <p:cNvSpPr/>
            <p:nvPr/>
          </p:nvSpPr>
          <p:spPr>
            <a:xfrm>
              <a:off x="2263680" y="637920"/>
              <a:ext cx="412920" cy="2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8" name="Group 76"/>
            <p:cNvGrpSpPr/>
            <p:nvPr/>
          </p:nvGrpSpPr>
          <p:grpSpPr>
            <a:xfrm>
              <a:off x="2139840" y="966600"/>
              <a:ext cx="676440" cy="330120"/>
              <a:chOff x="2139840" y="966600"/>
              <a:chExt cx="676440" cy="330120"/>
            </a:xfrm>
          </p:grpSpPr>
          <p:sp>
            <p:nvSpPr>
              <p:cNvPr id="89" name="AutoShape 77"/>
              <p:cNvSpPr/>
              <p:nvPr/>
            </p:nvSpPr>
            <p:spPr>
              <a:xfrm rot="5400000">
                <a:off x="2050920" y="1055160"/>
                <a:ext cx="330120" cy="152640"/>
              </a:xfrm>
              <a:custGeom>
                <a:avLst/>
                <a:gdLst>
                  <a:gd name="textAreaLeft" fmla="*/ 0 w 330120"/>
                  <a:gd name="textAreaRight" fmla="*/ 330480 w 330120"/>
                  <a:gd name="textAreaTop" fmla="*/ 0 h 152640"/>
                  <a:gd name="textAreaBottom" fmla="*/ 153000 h 152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AutoShape 78"/>
              <p:cNvSpPr/>
              <p:nvPr/>
            </p:nvSpPr>
            <p:spPr>
              <a:xfrm rot="5400000">
                <a:off x="2355480" y="1055520"/>
                <a:ext cx="330120" cy="152280"/>
              </a:xfrm>
              <a:custGeom>
                <a:avLst/>
                <a:gdLst>
                  <a:gd name="textAreaLeft" fmla="*/ 0 w 330120"/>
                  <a:gd name="textAreaRight" fmla="*/ 330480 w 330120"/>
                  <a:gd name="textAreaTop" fmla="*/ 0 h 152280"/>
                  <a:gd name="textAreaBottom" fmla="*/ 152640 h 152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AutoShape 79"/>
              <p:cNvSpPr/>
              <p:nvPr/>
            </p:nvSpPr>
            <p:spPr>
              <a:xfrm rot="5400000">
                <a:off x="2574720" y="1055160"/>
                <a:ext cx="330120" cy="152640"/>
              </a:xfrm>
              <a:custGeom>
                <a:avLst/>
                <a:gdLst>
                  <a:gd name="textAreaLeft" fmla="*/ 0 w 330120"/>
                  <a:gd name="textAreaRight" fmla="*/ 330480 w 330120"/>
                  <a:gd name="textAreaTop" fmla="*/ 0 h 152640"/>
                  <a:gd name="textAreaBottom" fmla="*/ 153000 h 152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AutoShape 80"/>
              <p:cNvSpPr/>
              <p:nvPr/>
            </p:nvSpPr>
            <p:spPr>
              <a:xfrm rot="5400000">
                <a:off x="2269800" y="1055520"/>
                <a:ext cx="330120" cy="152280"/>
              </a:xfrm>
              <a:custGeom>
                <a:avLst/>
                <a:gdLst>
                  <a:gd name="textAreaLeft" fmla="*/ 0 w 330120"/>
                  <a:gd name="textAreaRight" fmla="*/ 330480 w 330120"/>
                  <a:gd name="textAreaTop" fmla="*/ 0 h 152280"/>
                  <a:gd name="textAreaBottom" fmla="*/ 152640 h 152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3" name="Text Box 82"/>
            <p:cNvSpPr/>
            <p:nvPr/>
          </p:nvSpPr>
          <p:spPr>
            <a:xfrm>
              <a:off x="3416400" y="637920"/>
              <a:ext cx="412560" cy="2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4" name="Group 83"/>
            <p:cNvGrpSpPr/>
            <p:nvPr/>
          </p:nvGrpSpPr>
          <p:grpSpPr>
            <a:xfrm>
              <a:off x="3292200" y="966600"/>
              <a:ext cx="675720" cy="330120"/>
              <a:chOff x="3292200" y="966600"/>
              <a:chExt cx="675720" cy="330120"/>
            </a:xfrm>
          </p:grpSpPr>
          <p:sp>
            <p:nvSpPr>
              <p:cNvPr id="95" name="AutoShape 84"/>
              <p:cNvSpPr/>
              <p:nvPr/>
            </p:nvSpPr>
            <p:spPr>
              <a:xfrm rot="5400000">
                <a:off x="3203280" y="1055520"/>
                <a:ext cx="330120" cy="152280"/>
              </a:xfrm>
              <a:custGeom>
                <a:avLst/>
                <a:gdLst>
                  <a:gd name="textAreaLeft" fmla="*/ 0 w 330120"/>
                  <a:gd name="textAreaRight" fmla="*/ 330480 w 330120"/>
                  <a:gd name="textAreaTop" fmla="*/ 0 h 152280"/>
                  <a:gd name="textAreaBottom" fmla="*/ 152640 h 152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AutoShape 85"/>
              <p:cNvSpPr/>
              <p:nvPr/>
            </p:nvSpPr>
            <p:spPr>
              <a:xfrm rot="5400000">
                <a:off x="3507840" y="1055520"/>
                <a:ext cx="330120" cy="151920"/>
              </a:xfrm>
              <a:custGeom>
                <a:avLst/>
                <a:gdLst>
                  <a:gd name="textAreaLeft" fmla="*/ 0 w 330120"/>
                  <a:gd name="textAreaRight" fmla="*/ 330480 w 330120"/>
                  <a:gd name="textAreaTop" fmla="*/ 0 h 151920"/>
                  <a:gd name="textAreaBottom" fmla="*/ 152280 h 1519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AutoShape 86"/>
              <p:cNvSpPr/>
              <p:nvPr/>
            </p:nvSpPr>
            <p:spPr>
              <a:xfrm rot="5400000">
                <a:off x="3726720" y="1055520"/>
                <a:ext cx="330120" cy="152280"/>
              </a:xfrm>
              <a:custGeom>
                <a:avLst/>
                <a:gdLst>
                  <a:gd name="textAreaLeft" fmla="*/ 0 w 330120"/>
                  <a:gd name="textAreaRight" fmla="*/ 330480 w 330120"/>
                  <a:gd name="textAreaTop" fmla="*/ 0 h 152280"/>
                  <a:gd name="textAreaBottom" fmla="*/ 152640 h 152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AutoShape 87"/>
              <p:cNvSpPr/>
              <p:nvPr/>
            </p:nvSpPr>
            <p:spPr>
              <a:xfrm rot="5400000">
                <a:off x="3422160" y="1055520"/>
                <a:ext cx="330120" cy="151920"/>
              </a:xfrm>
              <a:custGeom>
                <a:avLst/>
                <a:gdLst>
                  <a:gd name="textAreaLeft" fmla="*/ 0 w 330120"/>
                  <a:gd name="textAreaRight" fmla="*/ 330480 w 330120"/>
                  <a:gd name="textAreaTop" fmla="*/ 0 h 151920"/>
                  <a:gd name="textAreaBottom" fmla="*/ 152280 h 1519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9" name="AutoShape 90"/>
            <p:cNvSpPr/>
            <p:nvPr/>
          </p:nvSpPr>
          <p:spPr>
            <a:xfrm rot="5400000">
              <a:off x="4336920" y="1055160"/>
              <a:ext cx="330120" cy="15264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640"/>
                <a:gd name="textAreaBottom" fmla="*/ 153000 h 152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AutoShape 91"/>
            <p:cNvSpPr/>
            <p:nvPr/>
          </p:nvSpPr>
          <p:spPr>
            <a:xfrm rot="5400000">
              <a:off x="4641480" y="1055520"/>
              <a:ext cx="330120" cy="15228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AutoShape 92"/>
            <p:cNvSpPr/>
            <p:nvPr/>
          </p:nvSpPr>
          <p:spPr>
            <a:xfrm rot="5400000">
              <a:off x="4860720" y="1055520"/>
              <a:ext cx="330120" cy="15228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AutoShape 93"/>
            <p:cNvSpPr/>
            <p:nvPr/>
          </p:nvSpPr>
          <p:spPr>
            <a:xfrm rot="5400000">
              <a:off x="4555800" y="1055520"/>
              <a:ext cx="330120" cy="152280"/>
            </a:xfrm>
            <a:custGeom>
              <a:avLst/>
              <a:gdLst>
                <a:gd name="textAreaLeft" fmla="*/ 0 w 330120"/>
                <a:gd name="textAreaRight" fmla="*/ 330480 w 3301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94"/>
            <p:cNvSpPr/>
            <p:nvPr/>
          </p:nvSpPr>
          <p:spPr>
            <a:xfrm>
              <a:off x="4794120" y="637920"/>
              <a:ext cx="463680" cy="2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95"/>
            <p:cNvSpPr/>
            <p:nvPr/>
          </p:nvSpPr>
          <p:spPr>
            <a:xfrm>
              <a:off x="4273560" y="637920"/>
              <a:ext cx="461880" cy="2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96"/>
            <p:cNvSpPr/>
            <p:nvPr/>
          </p:nvSpPr>
          <p:spPr>
            <a:xfrm>
              <a:off x="4530600" y="637920"/>
              <a:ext cx="412920" cy="2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98"/>
            <p:cNvSpPr/>
            <p:nvPr/>
          </p:nvSpPr>
          <p:spPr>
            <a:xfrm>
              <a:off x="4502160" y="134640"/>
              <a:ext cx="2666880" cy="509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-IFN</a:t>
              </a:r>
              <a:r>
                <a:rPr b="0" lang="it-IT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3 M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AutoShape 100"/>
            <p:cNvSpPr/>
            <p:nvPr/>
          </p:nvSpPr>
          <p:spPr>
            <a:xfrm rot="5400000">
              <a:off x="4196880" y="312480"/>
              <a:ext cx="304920" cy="152280"/>
            </a:xfrm>
            <a:custGeom>
              <a:avLst/>
              <a:gdLst>
                <a:gd name="textAreaLeft" fmla="*/ 0 w 304920"/>
                <a:gd name="textAreaRight" fmla="*/ 305280 w 3049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99"/>
            <p:cNvSpPr/>
            <p:nvPr/>
          </p:nvSpPr>
          <p:spPr>
            <a:xfrm>
              <a:off x="1149480" y="182160"/>
              <a:ext cx="3597120" cy="41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lanoma peptid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AutoShape 101"/>
            <p:cNvSpPr/>
            <p:nvPr/>
          </p:nvSpPr>
          <p:spPr>
            <a:xfrm rot="5400000">
              <a:off x="844200" y="312480"/>
              <a:ext cx="304920" cy="152280"/>
            </a:xfrm>
            <a:custGeom>
              <a:avLst/>
              <a:gdLst>
                <a:gd name="textAreaLeft" fmla="*/ 0 w 304920"/>
                <a:gd name="textAreaRight" fmla="*/ 305280 w 3049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102"/>
            <p:cNvSpPr/>
            <p:nvPr/>
          </p:nvSpPr>
          <p:spPr>
            <a:xfrm>
              <a:off x="1300320" y="1817280"/>
              <a:ext cx="504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lood withdrawal for Gene Profiling on PBMC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AutoShape 103"/>
            <p:cNvSpPr/>
            <p:nvPr/>
          </p:nvSpPr>
          <p:spPr>
            <a:xfrm flipV="1" rot="16200000">
              <a:off x="934560" y="1879200"/>
              <a:ext cx="304560" cy="152280"/>
            </a:xfrm>
            <a:custGeom>
              <a:avLst/>
              <a:gdLst>
                <a:gd name="textAreaLeft" fmla="*/ 0 w 304560"/>
                <a:gd name="textAreaRight" fmla="*/ 304920 w 304560"/>
                <a:gd name="textAreaTop" fmla="*/ -360 h 152280"/>
                <a:gd name="textAreaBottom" fmla="*/ 15228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74" y="0"/>
                  </a:lnTo>
                  <a:lnTo>
                    <a:pt x="21600" y="10800"/>
                  </a:lnTo>
                  <a:lnTo>
                    <a:pt x="1567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2" name="Gruppo 98"/>
            <p:cNvGrpSpPr/>
            <p:nvPr/>
          </p:nvGrpSpPr>
          <p:grpSpPr>
            <a:xfrm>
              <a:off x="343080" y="3519360"/>
              <a:ext cx="8466120" cy="942840"/>
              <a:chOff x="343080" y="3519360"/>
              <a:chExt cx="8466120" cy="942840"/>
            </a:xfrm>
          </p:grpSpPr>
          <p:grpSp>
            <p:nvGrpSpPr>
              <p:cNvPr id="113" name="Gruppo 97"/>
              <p:cNvGrpSpPr/>
              <p:nvPr/>
            </p:nvGrpSpPr>
            <p:grpSpPr>
              <a:xfrm>
                <a:off x="672120" y="3519360"/>
                <a:ext cx="8137080" cy="942840"/>
                <a:chOff x="672120" y="3519360"/>
                <a:chExt cx="8137080" cy="942840"/>
              </a:xfrm>
            </p:grpSpPr>
            <p:sp>
              <p:nvSpPr>
                <p:cNvPr id="114" name="Text Box 2"/>
                <p:cNvSpPr/>
                <p:nvPr/>
              </p:nvSpPr>
              <p:spPr>
                <a:xfrm>
                  <a:off x="7255080" y="3519360"/>
                  <a:ext cx="706320" cy="255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 anchorCtr="1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6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Text Box 3"/>
                <p:cNvSpPr/>
                <p:nvPr/>
              </p:nvSpPr>
              <p:spPr>
                <a:xfrm>
                  <a:off x="5725800" y="3519360"/>
                  <a:ext cx="593640" cy="269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 anchorCtr="1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2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Text Box 4"/>
                <p:cNvSpPr/>
                <p:nvPr/>
              </p:nvSpPr>
              <p:spPr>
                <a:xfrm>
                  <a:off x="7824960" y="3519360"/>
                  <a:ext cx="984240" cy="269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 anchorCtr="1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6m+2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AutoShape 5"/>
                <p:cNvSpPr/>
                <p:nvPr/>
              </p:nvSpPr>
              <p:spPr>
                <a:xfrm flipV="1" rot="16200000">
                  <a:off x="940320" y="422280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4" y="0"/>
                      </a:lnTo>
                      <a:lnTo>
                        <a:pt x="21600" y="10800"/>
                      </a:lnTo>
                      <a:lnTo>
                        <a:pt x="15674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AutoShape 6"/>
                <p:cNvSpPr/>
                <p:nvPr/>
              </p:nvSpPr>
              <p:spPr>
                <a:xfrm flipV="1" rot="16200000">
                  <a:off x="1504080" y="422280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4" y="0"/>
                      </a:lnTo>
                      <a:lnTo>
                        <a:pt x="21600" y="10800"/>
                      </a:lnTo>
                      <a:lnTo>
                        <a:pt x="15674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Text Box 7"/>
                <p:cNvSpPr/>
                <p:nvPr/>
              </p:nvSpPr>
              <p:spPr>
                <a:xfrm>
                  <a:off x="672120" y="3519360"/>
                  <a:ext cx="582480" cy="2966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    </a:t>
                  </a: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Text Box 8"/>
                <p:cNvSpPr/>
                <p:nvPr/>
              </p:nvSpPr>
              <p:spPr>
                <a:xfrm>
                  <a:off x="1232280" y="3519360"/>
                  <a:ext cx="965160" cy="2696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  </a:t>
                  </a: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0+2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Text Box 9"/>
                <p:cNvSpPr/>
                <p:nvPr/>
              </p:nvSpPr>
              <p:spPr>
                <a:xfrm>
                  <a:off x="3920400" y="3519360"/>
                  <a:ext cx="1052640" cy="360360"/>
                </a:xfrm>
                <a:prstGeom prst="rect">
                  <a:avLst/>
                </a:prstGeom>
                <a:noFill/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1m+24h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AutoShape 10"/>
                <p:cNvSpPr/>
                <p:nvPr/>
              </p:nvSpPr>
              <p:spPr>
                <a:xfrm flipV="1" rot="16200000">
                  <a:off x="3580560" y="423360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4" y="0"/>
                      </a:lnTo>
                      <a:lnTo>
                        <a:pt x="21600" y="10800"/>
                      </a:lnTo>
                      <a:lnTo>
                        <a:pt x="15674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AutoShape 11"/>
                <p:cNvSpPr/>
                <p:nvPr/>
              </p:nvSpPr>
              <p:spPr>
                <a:xfrm flipV="1" rot="16200000">
                  <a:off x="4147560" y="423360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4" y="0"/>
                      </a:lnTo>
                      <a:lnTo>
                        <a:pt x="21600" y="10800"/>
                      </a:lnTo>
                      <a:lnTo>
                        <a:pt x="15674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Text Box 12"/>
                <p:cNvSpPr/>
                <p:nvPr/>
              </p:nvSpPr>
              <p:spPr>
                <a:xfrm>
                  <a:off x="3301200" y="3519360"/>
                  <a:ext cx="762120" cy="360360"/>
                </a:xfrm>
                <a:prstGeom prst="rect">
                  <a:avLst/>
                </a:prstGeom>
                <a:noFill/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  </a:t>
                  </a: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1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Line 13"/>
                <p:cNvSpPr/>
                <p:nvPr/>
              </p:nvSpPr>
              <p:spPr>
                <a:xfrm>
                  <a:off x="3583800" y="3903480"/>
                  <a:ext cx="0" cy="10152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Line 14"/>
                <p:cNvSpPr/>
                <p:nvPr/>
              </p:nvSpPr>
              <p:spPr>
                <a:xfrm>
                  <a:off x="3831480" y="3903480"/>
                  <a:ext cx="0" cy="10152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AutoShape 15"/>
                <p:cNvSpPr/>
                <p:nvPr/>
              </p:nvSpPr>
              <p:spPr>
                <a:xfrm rot="5400000">
                  <a:off x="5902560" y="389556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5" y="0"/>
                      </a:lnTo>
                      <a:lnTo>
                        <a:pt x="21600" y="10800"/>
                      </a:lnTo>
                      <a:lnTo>
                        <a:pt x="15675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b3b3b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AutoShape 16"/>
                <p:cNvSpPr/>
                <p:nvPr/>
              </p:nvSpPr>
              <p:spPr>
                <a:xfrm rot="5400000">
                  <a:off x="5806800" y="389556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4" y="0"/>
                      </a:lnTo>
                      <a:lnTo>
                        <a:pt x="21600" y="10800"/>
                      </a:lnTo>
                      <a:lnTo>
                        <a:pt x="15674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AutoShape 17"/>
                <p:cNvSpPr/>
                <p:nvPr/>
              </p:nvSpPr>
              <p:spPr>
                <a:xfrm rot="5400000">
                  <a:off x="7544160" y="389556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5" y="0"/>
                      </a:lnTo>
                      <a:lnTo>
                        <a:pt x="21600" y="10800"/>
                      </a:lnTo>
                      <a:lnTo>
                        <a:pt x="15675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b3b3b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AutoShape 18"/>
                <p:cNvSpPr/>
                <p:nvPr/>
              </p:nvSpPr>
              <p:spPr>
                <a:xfrm rot="5400000">
                  <a:off x="7448760" y="389556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4" y="0"/>
                      </a:lnTo>
                      <a:lnTo>
                        <a:pt x="21600" y="10800"/>
                      </a:lnTo>
                      <a:lnTo>
                        <a:pt x="15674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AutoShape 19"/>
                <p:cNvSpPr/>
                <p:nvPr/>
              </p:nvSpPr>
              <p:spPr>
                <a:xfrm rot="5400000">
                  <a:off x="1076400" y="389556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5" y="0"/>
                      </a:lnTo>
                      <a:lnTo>
                        <a:pt x="21600" y="10800"/>
                      </a:lnTo>
                      <a:lnTo>
                        <a:pt x="15675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b3b3b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AutoShape 20"/>
                <p:cNvSpPr/>
                <p:nvPr/>
              </p:nvSpPr>
              <p:spPr>
                <a:xfrm rot="5400000">
                  <a:off x="978480" y="389556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4" y="0"/>
                      </a:lnTo>
                      <a:lnTo>
                        <a:pt x="21600" y="10800"/>
                      </a:lnTo>
                      <a:lnTo>
                        <a:pt x="15674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AutoShape 21"/>
                <p:cNvSpPr/>
                <p:nvPr/>
              </p:nvSpPr>
              <p:spPr>
                <a:xfrm rot="5400000">
                  <a:off x="3724200" y="388116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5" y="0"/>
                      </a:lnTo>
                      <a:lnTo>
                        <a:pt x="21600" y="10800"/>
                      </a:lnTo>
                      <a:lnTo>
                        <a:pt x="15675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b3b3b3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AutoShape 22"/>
                <p:cNvSpPr/>
                <p:nvPr/>
              </p:nvSpPr>
              <p:spPr>
                <a:xfrm rot="5400000">
                  <a:off x="3628440" y="3881160"/>
                  <a:ext cx="301680" cy="15552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155520"/>
                    <a:gd name="textAreaBottom" fmla="*/ 155520 h 1555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5674" y="0"/>
                      </a:lnTo>
                      <a:lnTo>
                        <a:pt x="21600" y="10800"/>
                      </a:lnTo>
                      <a:lnTo>
                        <a:pt x="15674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anchorCtr="1" vert="eaVert" rot="10800000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5" name="Line 104"/>
              <p:cNvSpPr/>
              <p:nvPr/>
            </p:nvSpPr>
            <p:spPr>
              <a:xfrm>
                <a:off x="343080" y="4141800"/>
                <a:ext cx="8448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6" name="Text Box 105"/>
            <p:cNvSpPr/>
            <p:nvPr/>
          </p:nvSpPr>
          <p:spPr>
            <a:xfrm>
              <a:off x="295200" y="79200"/>
              <a:ext cx="533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 Box 106"/>
            <p:cNvSpPr/>
            <p:nvPr/>
          </p:nvSpPr>
          <p:spPr>
            <a:xfrm>
              <a:off x="311040" y="2550960"/>
              <a:ext cx="533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8" name="Gruppo 101"/>
            <p:cNvGrpSpPr/>
            <p:nvPr/>
          </p:nvGrpSpPr>
          <p:grpSpPr>
            <a:xfrm>
              <a:off x="1010880" y="4651200"/>
              <a:ext cx="5334480" cy="304560"/>
              <a:chOff x="1010880" y="4651200"/>
              <a:chExt cx="5334480" cy="304560"/>
            </a:xfrm>
          </p:grpSpPr>
          <p:sp>
            <p:nvSpPr>
              <p:cNvPr id="139" name="Text Box 102"/>
              <p:cNvSpPr/>
              <p:nvPr/>
            </p:nvSpPr>
            <p:spPr>
              <a:xfrm>
                <a:off x="1299960" y="4664880"/>
                <a:ext cx="5045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lood withdrawal for Gene Profiling on PBMC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AutoShape 103"/>
              <p:cNvSpPr/>
              <p:nvPr/>
            </p:nvSpPr>
            <p:spPr>
              <a:xfrm flipV="1" rot="16200000">
                <a:off x="934560" y="4727160"/>
                <a:ext cx="304560" cy="152280"/>
              </a:xfrm>
              <a:custGeom>
                <a:avLst/>
                <a:gdLst>
                  <a:gd name="textAreaLeft" fmla="*/ 0 w 304560"/>
                  <a:gd name="textAreaRight" fmla="*/ 304920 w 304560"/>
                  <a:gd name="textAreaTop" fmla="*/ -360 h 152280"/>
                  <a:gd name="textAreaBottom" fmla="*/ 152280 h 152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5674" y="0"/>
                    </a:lnTo>
                    <a:lnTo>
                      <a:pt x="21600" y="10800"/>
                    </a:lnTo>
                    <a:lnTo>
                      <a:pt x="15674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2T17:25:18Z</dcterms:created>
  <dc:creator>eleonora aricò</dc:creator>
  <dc:description/>
  <dc:language>en-US</dc:language>
  <cp:lastModifiedBy>eleonora aricò</cp:lastModifiedBy>
  <dcterms:modified xsi:type="dcterms:W3CDTF">2011-04-18T14:57:55Z</dcterms:modified>
  <cp:revision>3</cp:revision>
  <dc:subject/>
  <dc:title>Slide 1</dc:title>
</cp:coreProperties>
</file>